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A8F3F-5C0F-4E1D-A96D-CC02B648BD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C637B-87A6-4EAD-B711-C677859041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36FA7-F6F4-4D80-A8B1-DB4190680D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DF935-F478-427E-A0E3-98656F327C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7D6EF5-93AD-4210-AAD1-E03132BB2B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C01B4-91AC-4709-82EA-FC872E203B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64522-9BC9-436A-A1D1-ECE05316DC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CEACC-AA48-493A-AF7A-D154A9E066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0BD56-8FED-4A42-9BE6-D4CAF24ACC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D6215-C182-4AC0-B1ED-447E468750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EF4A4-8AC0-48FF-B334-9C65440847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D14A6D-F969-4962-A4A5-CD3BD3A4EE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67381D-2AC9-4324-B629-F2F1F4ABCAAF}" type="slidenum">
              <a:rPr b="0" lang="ko-K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8"/>
          <p:cNvGrpSpPr/>
          <p:nvPr/>
        </p:nvGrpSpPr>
        <p:grpSpPr>
          <a:xfrm>
            <a:off x="260280" y="306360"/>
            <a:ext cx="3638520" cy="2743200"/>
            <a:chOff x="260280" y="306360"/>
            <a:chExt cx="3638520" cy="2743200"/>
          </a:xfrm>
        </p:grpSpPr>
        <p:graphicFrame>
          <p:nvGraphicFramePr>
            <p:cNvPr id="42" name="차트 4"/>
            <p:cNvGraphicFramePr/>
            <p:nvPr/>
          </p:nvGraphicFramePr>
          <p:xfrm>
            <a:off x="260280" y="306360"/>
            <a:ext cx="3638520" cy="27432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차트 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60280" y="306360"/>
                      <a:ext cx="3638520" cy="2743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직선 연결선 6"/>
            <p:cNvSpPr/>
            <p:nvPr/>
          </p:nvSpPr>
          <p:spPr>
            <a:xfrm>
              <a:off x="1517400" y="580320"/>
              <a:ext cx="1760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7"/>
            <p:cNvSpPr/>
            <p:nvPr/>
          </p:nvSpPr>
          <p:spPr>
            <a:xfrm>
              <a:off x="2251080" y="355320"/>
              <a:ext cx="30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TextBox 9"/>
          <p:cNvSpPr/>
          <p:nvPr/>
        </p:nvSpPr>
        <p:spPr>
          <a:xfrm>
            <a:off x="0" y="4338720"/>
            <a:ext cx="91440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한양신명조,한컴돋움"/>
              </a:rPr>
              <a:t>Additional file 1: Figure S1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한양신명조,한컴돋움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an fluorescence intensity (MFI) of Foxp3+CD25+CD4+ T cell in LLN of airway inflammation induced mice.  MFI value of Foxp3+CD25+ in LLN of ASC sup treated and asthma induced mice have significantly higher than those of value</a:t>
            </a:r>
            <a:r>
              <a:rPr b="0" lang="ko-K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hma induced mice (**, p&lt;0.001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08T02:12:53Z</dcterms:created>
  <dc:creator>Hak Sun Yu</dc:creator>
  <dc:description/>
  <dc:language>en-US</dc:language>
  <cp:lastModifiedBy>para</cp:lastModifiedBy>
  <dcterms:modified xsi:type="dcterms:W3CDTF">2016-12-30T01:58:02Z</dcterms:modified>
  <cp:revision>4</cp:revision>
  <dc:subject/>
  <dc:title>PowerPoint 프레젠테이션</dc:title>
</cp:coreProperties>
</file>